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png" ContentType="image/png"/>
  <Override PartName="/ppt/media/image2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F2007-204F-42B9-AAE6-052A519BA8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539640" y="427032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1B0A4B-3D5E-4476-913C-C8F0F3C4FE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452232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F02C7C-C7D8-483C-82CB-56F27EA69A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37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3"/>
          <p:cNvSpPr>
            <a:spLocks noGrp="1"/>
          </p:cNvSpPr>
          <p:nvPr>
            <p:ph/>
          </p:nvPr>
        </p:nvSpPr>
        <p:spPr>
          <a:xfrm>
            <a:off x="316764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4"/>
          <p:cNvSpPr>
            <a:spLocks noGrp="1"/>
          </p:cNvSpPr>
          <p:nvPr>
            <p:ph/>
          </p:nvPr>
        </p:nvSpPr>
        <p:spPr>
          <a:xfrm>
            <a:off x="579528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5"/>
          <p:cNvSpPr>
            <a:spLocks noGrp="1"/>
          </p:cNvSpPr>
          <p:nvPr>
            <p:ph/>
          </p:nvPr>
        </p:nvSpPr>
        <p:spPr>
          <a:xfrm>
            <a:off x="53964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6"/>
          <p:cNvSpPr>
            <a:spLocks noGrp="1"/>
          </p:cNvSpPr>
          <p:nvPr>
            <p:ph/>
          </p:nvPr>
        </p:nvSpPr>
        <p:spPr>
          <a:xfrm>
            <a:off x="316764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7"/>
          <p:cNvSpPr>
            <a:spLocks noGrp="1"/>
          </p:cNvSpPr>
          <p:nvPr>
            <p:ph/>
          </p:nvPr>
        </p:nvSpPr>
        <p:spPr>
          <a:xfrm>
            <a:off x="579528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79F633-09CA-4E7C-AB81-496C2539DE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539640" y="10537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subTitle"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1D90F-EC3E-43E7-8723-3DE2A4DDDC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52232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539640" y="427032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52232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16764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5795280" y="212076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53964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16764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5795280" y="427032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B92BC-FE61-47CB-BEF1-9047910A84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EE81DD-AA5D-4EA7-8E9C-F6ECEDA189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DDECD1-0BAC-498B-A72E-2DEAABC920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subTitle"/>
          </p:nvPr>
        </p:nvSpPr>
        <p:spPr>
          <a:xfrm>
            <a:off x="539640" y="10537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B12C5-BD5D-46E9-A63D-1CB9AE52E6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B3CC0-B80D-476C-A135-1441E2CF64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4522320" y="427032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9217B-9207-4DAD-A86B-68B54B126F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53964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4522320" y="212076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/>
          </p:nvPr>
        </p:nvSpPr>
        <p:spPr>
          <a:xfrm>
            <a:off x="539640" y="427032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64D4B8-6ACA-4A67-AE16-8A3909AAD2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0" name="Picture 10" descr=""/>
          <p:cNvPicPr/>
          <p:nvPr/>
        </p:nvPicPr>
        <p:blipFill>
          <a:blip r:embed="rId2"/>
          <a:stretch/>
        </p:blipFill>
        <p:spPr>
          <a:xfrm>
            <a:off x="7178760" y="182520"/>
            <a:ext cx="1727280" cy="704880"/>
          </a:xfrm>
          <a:prstGeom prst="rect">
            <a:avLst/>
          </a:prstGeom>
          <a:ln w="0">
            <a:noFill/>
          </a:ln>
        </p:spPr>
      </p:pic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870052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body"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870052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000000"/>
              </a:buClr>
              <a:buFont typeface="Wingdings" charset="2"/>
              <a:buChar char="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870052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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499"/>
              </a:spcBef>
              <a:buClr>
                <a:srgbClr val="870052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dt" idx="1"/>
          </p:nvPr>
        </p:nvSpPr>
        <p:spPr>
          <a:xfrm>
            <a:off x="6553080" y="6476760"/>
            <a:ext cx="190512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800" spc="-1" strike="noStrike">
                <a:solidFill>
                  <a:srgbClr val="80808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6317FF-7305-4CBD-863B-EAEAFFA6BEFD}" type="datetime3">
              <a:rPr b="0" lang="sv-SE" sz="800" spc="-1" strike="noStrike">
                <a:solidFill>
                  <a:srgbClr val="808080"/>
                </a:solidFill>
                <a:latin typeface="Arial"/>
              </a:rPr>
              <a:t>29 augusti 2026</a:t>
            </a:fld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ftr" idx="2"/>
          </p:nvPr>
        </p:nvSpPr>
        <p:spPr>
          <a:xfrm>
            <a:off x="456840" y="6476760"/>
            <a:ext cx="289548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800" spc="-1" strike="noStrike">
                <a:solidFill>
                  <a:srgbClr val="80808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800" spc="-1" strike="noStrike">
                <a:solidFill>
                  <a:srgbClr val="808080"/>
                </a:solidFill>
                <a:latin typeface="Arial"/>
              </a:rPr>
              <a:t>Ulf Gehrmann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sldNum" idx="3"/>
          </p:nvPr>
        </p:nvSpPr>
        <p:spPr>
          <a:xfrm>
            <a:off x="8229240" y="6476760"/>
            <a:ext cx="685800" cy="22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sv-SE" sz="800" spc="-1" strike="noStrike">
                <a:solidFill>
                  <a:srgbClr val="80808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193850-2B77-4984-8978-CAB90B889631}" type="slidenum">
              <a:rPr b="1" lang="sv-SE" sz="800" spc="-1" strike="noStrike">
                <a:solidFill>
                  <a:srgbClr val="808080"/>
                </a:solidFill>
                <a:latin typeface="Arial"/>
              </a:rPr>
              <a:t>&lt;number&gt;</a:t>
            </a:fld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Line 7"/>
          <p:cNvSpPr/>
          <p:nvPr/>
        </p:nvSpPr>
        <p:spPr>
          <a:xfrm>
            <a:off x="533520" y="6400800"/>
            <a:ext cx="8305560" cy="0"/>
          </a:xfrm>
          <a:prstGeom prst="line">
            <a:avLst/>
          </a:prstGeom>
          <a:ln w="9360">
            <a:solidFill>
              <a:srgbClr val="87005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14" descr=""/>
          <p:cNvPicPr/>
          <p:nvPr/>
        </p:nvPicPr>
        <p:blipFill>
          <a:blip r:embed="rId2"/>
          <a:srcRect l="1666" t="2221" r="1681" b="2247"/>
          <a:stretch/>
        </p:blipFill>
        <p:spPr>
          <a:xfrm>
            <a:off x="152280" y="152280"/>
            <a:ext cx="8839440" cy="6553440"/>
          </a:xfrm>
          <a:prstGeom prst="rect">
            <a:avLst/>
          </a:prstGeom>
          <a:ln w="0">
            <a:noFill/>
          </a:ln>
        </p:spPr>
      </p:pic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539640" y="1053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870052"/>
                </a:solidFill>
                <a:latin typeface="Arial"/>
              </a:rPr>
              <a:t>Click to edit the title text format</a:t>
            </a:r>
            <a:endParaRPr b="1" lang="en-US" sz="2800" spc="-1" strike="noStrike">
              <a:solidFill>
                <a:srgbClr val="870052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539640" y="212076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870052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499"/>
              </a:spcBef>
              <a:buClr>
                <a:srgbClr val="000000"/>
              </a:buClr>
              <a:buFont typeface="Wingdings" charset="2"/>
              <a:buChar char="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499"/>
              </a:spcBef>
              <a:buClr>
                <a:srgbClr val="870052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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499"/>
              </a:spcBef>
              <a:buClr>
                <a:srgbClr val="870052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499"/>
              </a:spcBef>
              <a:buClr>
                <a:srgbClr val="000000"/>
              </a:buClr>
              <a:buFont typeface="Wingdings" charset="2"/>
              <a:buChar char="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2" name=""/>
          <p:cNvGraphicFramePr/>
          <p:nvPr/>
        </p:nvGraphicFramePr>
        <p:xfrm>
          <a:off x="324000" y="981000"/>
          <a:ext cx="6264000" cy="3281400"/>
        </p:xfrm>
        <a:graphic>
          <a:graphicData uri="http://schemas.openxmlformats.org/drawingml/2006/table">
            <a:tbl>
              <a:tblPr/>
              <a:tblGrid>
                <a:gridCol w="2001600"/>
                <a:gridCol w="2078280"/>
                <a:gridCol w="2184120"/>
              </a:tblGrid>
              <a:tr h="9352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Source of exosomes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HC</a:t>
                      </a:r>
                      <a:r>
                        <a:rPr b="1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*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Median (range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AE</a:t>
                      </a:r>
                      <a:r>
                        <a:rPr b="1" lang="en-GB" sz="14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†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Median (range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015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DCexo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2)</a:t>
                      </a:r>
                      <a:br>
                        <a:rPr sz="1400"/>
                      </a:b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µg/1 x 10</a:t>
                      </a:r>
                      <a:r>
                        <a:rPr b="0" lang="en-GB" sz="14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6</a:t>
                      </a: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 cells)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n=6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2.82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0.37 – 5.89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3.53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0.93 – 8.84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6015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DCexo Mala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2)</a:t>
                      </a:r>
                      <a:br>
                        <a:rPr sz="1400"/>
                      </a:b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µg/1 x 10</a:t>
                      </a:r>
                      <a:r>
                        <a:rPr b="0" lang="en-GB" sz="14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6</a:t>
                      </a: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 cells)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n=6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2.26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1.09 – 6.85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2.77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0.78 – 10.70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16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Plexos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3)</a:t>
                      </a:r>
                      <a:br>
                        <a:rPr sz="1400"/>
                      </a:b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µg/ml plasma)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n=8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1.97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1.13 – 2.30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2.03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1.34 – 3.22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713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MalaEx</a:t>
                      </a:r>
                      <a:r>
                        <a:rPr b="0" lang="en-US" sz="14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2)</a:t>
                      </a:r>
                      <a:br>
                        <a:rPr sz="1400"/>
                      </a:b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µg/1 x 10</a:t>
                      </a:r>
                      <a:r>
                        <a:rPr b="0" lang="en-GB" sz="14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6</a:t>
                      </a: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 cells)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n=5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0.19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ＭＳ 明朝"/>
                        </a:rPr>
                        <a:t>(0.09 – 0.62)</a:t>
                      </a:r>
                      <a:endParaRPr b="1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83" name="Text Box 34"/>
          <p:cNvSpPr/>
          <p:nvPr/>
        </p:nvSpPr>
        <p:spPr>
          <a:xfrm>
            <a:off x="250920" y="115920"/>
            <a:ext cx="2160360" cy="297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400" spc="-1" strike="noStrike">
                <a:solidFill>
                  <a:srgbClr val="000000"/>
                </a:solidFill>
                <a:latin typeface="Arial"/>
                <a:ea typeface="ＭＳ 明朝"/>
              </a:rPr>
              <a:t>Table S2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8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1T16:16:51Z</dcterms:created>
  <dc:creator>QARH</dc:creator>
  <dc:description/>
  <dc:language>en-US</dc:language>
  <cp:lastModifiedBy>Ulf Gehrmann</cp:lastModifiedBy>
  <cp:lastPrinted>2005-09-23T14:22:03Z</cp:lastPrinted>
  <dcterms:modified xsi:type="dcterms:W3CDTF">2011-06-21T08:59:41Z</dcterms:modified>
  <cp:revision>259</cp:revision>
  <dc:subject/>
  <dc:title>The role of exosomes in immune regulation and allergy</dc:title>
</cp:coreProperties>
</file>